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0879138" cy="12438063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BD19FA-F835-488C-8C65-1AD1E3A8D6D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44320" y="496440"/>
            <a:ext cx="9791640" cy="2073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44320" y="2901960"/>
            <a:ext cx="9791640" cy="3914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44320" y="7188840"/>
            <a:ext cx="9791640" cy="3914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F45408-EE95-4569-BDDB-9AF47FA0686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44320" y="496440"/>
            <a:ext cx="9791640" cy="2073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44320" y="2901960"/>
            <a:ext cx="4778280" cy="3914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562000" y="2901960"/>
            <a:ext cx="4778280" cy="3914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44320" y="7188840"/>
            <a:ext cx="4778280" cy="3914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562000" y="7188840"/>
            <a:ext cx="4778280" cy="3914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936894-10B8-403C-B610-DB754A04A1E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44320" y="496440"/>
            <a:ext cx="9791640" cy="2073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44320" y="2901960"/>
            <a:ext cx="3152520" cy="3914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854880" y="2901960"/>
            <a:ext cx="3152520" cy="3914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165440" y="2901960"/>
            <a:ext cx="3152520" cy="3914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44320" y="7188840"/>
            <a:ext cx="3152520" cy="3914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854880" y="7188840"/>
            <a:ext cx="3152520" cy="3914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165440" y="7188840"/>
            <a:ext cx="3152520" cy="3914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7559F4-41C5-452B-80F5-CF0F503FF6B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44320" y="496440"/>
            <a:ext cx="9791640" cy="2073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44320" y="2901960"/>
            <a:ext cx="9791640" cy="820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631838-DECD-47A4-9D36-A254A9B5727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44320" y="496440"/>
            <a:ext cx="9791640" cy="2073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44320" y="2901960"/>
            <a:ext cx="9791640" cy="8207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88832A-FCF0-4E7E-BD68-01FF49442B7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44320" y="496440"/>
            <a:ext cx="9791640" cy="2073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44320" y="2901960"/>
            <a:ext cx="4778280" cy="8207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562000" y="2901960"/>
            <a:ext cx="4778280" cy="8207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369483-1BA7-4E3F-A3FE-7070809D813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44320" y="496440"/>
            <a:ext cx="9791640" cy="2073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CDBE0A-AD7A-4A49-A022-6398340DD84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44320" y="496440"/>
            <a:ext cx="9791640" cy="9611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3598BF-0036-4FF1-A40F-D4B0E4008F2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44320" y="496440"/>
            <a:ext cx="9791640" cy="2073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44320" y="2901960"/>
            <a:ext cx="4778280" cy="3914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562000" y="2901960"/>
            <a:ext cx="4778280" cy="8207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44320" y="7188840"/>
            <a:ext cx="4778280" cy="3914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98E236-0747-4D55-844B-3E6194CB7B3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44320" y="496440"/>
            <a:ext cx="9791640" cy="2073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44320" y="2901960"/>
            <a:ext cx="4778280" cy="8207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562000" y="2901960"/>
            <a:ext cx="4778280" cy="3914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562000" y="7188840"/>
            <a:ext cx="4778280" cy="3914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B82631-211B-4CEB-BE95-2A30CA6408F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44320" y="496440"/>
            <a:ext cx="9791640" cy="2073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44320" y="2901960"/>
            <a:ext cx="4778280" cy="3914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562000" y="2901960"/>
            <a:ext cx="4778280" cy="3914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44320" y="7188840"/>
            <a:ext cx="9791640" cy="3914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35B069-F79C-4A3D-B05E-911D592B06A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44320" y="496440"/>
            <a:ext cx="9791640" cy="2073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44320" y="2901960"/>
            <a:ext cx="9791640" cy="8207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44320" y="11324880"/>
            <a:ext cx="2538360" cy="863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717720" y="11324880"/>
            <a:ext cx="3444840" cy="863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797600" y="11324880"/>
            <a:ext cx="2538360" cy="863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EA5FB0F-B996-4BC8-A5BC-871F8892388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046240" y="2508120"/>
            <a:ext cx="21924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1849320" y="2282760"/>
            <a:ext cx="990720" cy="702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023310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13439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116165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12156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11616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09156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0251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10075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1007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1093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07344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09130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1387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05587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12004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01079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01932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0261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09105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13942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13598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12376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12409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02567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02713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00971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01348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0683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02710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10475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108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13599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12660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01129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11029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12633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13670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09116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7421400" y="2508120"/>
            <a:ext cx="21924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7862040" y="2282760"/>
            <a:ext cx="1852560" cy="7212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8,946,080-19,123,5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9,018,718-19,150,96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0,016,308-20,560,05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0,219,373-20,337,87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0,253,831-20,428,07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0,732,382-20,913,164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0,808,716-20,988,60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0,894,308-21,066,29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1,116,295-21,290,12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1,137,787-21,280,233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1,129,692-21,314,46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6,199,529-26,378,74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6,478,747-26,641,134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6,704,202-26,896,735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8,097,023-28,285,618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8,333,050-28,512,55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8,382,082-28,557,28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8,579,149-28,696,04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8,694,446-28,838,99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0,300,324-30,488,77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0,480,746-30,654,13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0,591,211-30,777,70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0,637,967-30,777,67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2,346,899-32,537,40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2,518,432-32,669,92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70,693,862-70,907,60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72,002,163-72,164,22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73,280,946-73,455,13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73,856,953-74,037,11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75,933,309-76,109,08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0,305,421-80,472,5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0,459,436-80,616,7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0,913,891-81,082,94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0,738,494-80,887,17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0,920,679-81,107,58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0,676,701-80,772,19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2,701,124-82,775,47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8,480,521-88,682,90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6192360" y="2303640"/>
            <a:ext cx="607320" cy="702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q11.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q11.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q11.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q11.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q11.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q11.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q11.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q11.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q11.2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q11.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q13.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q13.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q13.1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q13.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q13.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q13.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q13.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q13.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q13.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q13.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q13.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q13.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q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q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q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q24.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q24.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q24.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q24.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q24.3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q25.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q25.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q25.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q25.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q25.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q25.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q25.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q26.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1087920" y="2303640"/>
            <a:ext cx="351360" cy="702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3294360" y="2306520"/>
            <a:ext cx="1209600" cy="7060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P11-336L20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TC-803A3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P11-467N20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TD-2024P22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P11-475F15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P11-228M15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P11-291O21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P11-566K19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P11-262J5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P11-228G18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P11-757E13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P11-483E23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P11-536P16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P11-578F21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P11-932O9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P11-40J8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P11-382B18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P11-605N15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P11-736I24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P13-395E19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P11-632K20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P11-1000B6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P11-1203N1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P11-602M11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RP11-1H8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P11-361M10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P11-2M12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P11-817O13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P11-326L17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P11-114H24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TD-2116G1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P13-608F4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P11-606M5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P11-96J23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P11-379H8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P13-98N21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P11-671M22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P11-697E2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5201640" y="2282760"/>
            <a:ext cx="522000" cy="7212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61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616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617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612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596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13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12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621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11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11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11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602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60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11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11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02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02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02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33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09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04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03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02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69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75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26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28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33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2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18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08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02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13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13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12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12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06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18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1163520" y="9445680"/>
            <a:ext cx="8382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1163520" y="2293920"/>
            <a:ext cx="8382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1163520" y="1825560"/>
            <a:ext cx="8382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1154160" y="1825560"/>
            <a:ext cx="78372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        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ccession No.              BAC Clone ID       BLASTN E score     Cyto. Band                Genomic loca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         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b                           (bp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985680" y="1405080"/>
            <a:ext cx="8121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Table S3.  The distribution of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GOLGA8E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associated low copy repeats in the15q11-q14 and 15q24-q26 regions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7043760" y="2309760"/>
            <a:ext cx="479520" cy="702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8.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9.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0.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0.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0.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0.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0.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0.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1.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1.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1.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6.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6.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6.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8.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8.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8.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8.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8.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0.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0.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0.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0.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2.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2.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70.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72.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73.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73.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75.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0.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0.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0.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0.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1.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0.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2.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8.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7183440" y="2054160"/>
            <a:ext cx="2286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6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5-06-16T01:29:48Z</dcterms:created>
  <dc:creator>Baylor</dc:creator>
  <dc:description/>
  <dc:language>en-US</dc:language>
  <cp:lastModifiedBy>yjiang</cp:lastModifiedBy>
  <dcterms:modified xsi:type="dcterms:W3CDTF">2007-11-21T22:57:19Z</dcterms:modified>
  <cp:revision>46</cp:revision>
  <dc:subject/>
  <dc:title>Slide 1</dc:title>
</cp:coreProperties>
</file>